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4/2026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D26A04-4588-6C34-B499-74B1BDBE1C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92FB034-8F00-76F4-D073-8B9F99390C3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AEA1AC5-FBA1-EBA2-5E45-F040B0A18EC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9E50ED-490B-7538-E20F-5256EAFEA90D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222450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6DF7BD-9174-8291-F220-95FAF37CB4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F1524633-4FC2-556F-29BC-2B3E64442FE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E86680F-D2C3-7D7E-35E2-B2C150A7E2C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C97AA6-A1D4-0EC1-4817-EFD93C21297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3287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4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720" y="5705380"/>
            <a:ext cx="684076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en et al (2026) Diabetologia DOI 10.1007/s00125-026-06731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6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ummary of human pancreas biobanks included in the BioPanc Donor Atlas (https://clekka.shinyapps.io/biopanc_donor_atlas/)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0F12DE5-F56B-BD4A-355F-5F60C1D0A3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4442" y="1050413"/>
            <a:ext cx="6095116" cy="5042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DA43D6C-1402-25AF-2CFF-8D5A877C1A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5782E99B-ACEE-8421-5FF9-C07791681F4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5A1D19-3F44-21CB-2F17-CB7E6038E759}"/>
              </a:ext>
            </a:extLst>
          </p:cNvPr>
          <p:cNvSpPr txBox="1"/>
          <p:nvPr/>
        </p:nvSpPr>
        <p:spPr>
          <a:xfrm>
            <a:off x="26296" y="5661248"/>
            <a:ext cx="684076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en et al (2026) Diabetologia DOI 10.1007/s00125-026-06731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6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0546C63-DF80-2F9D-8CD6-DDD7D475CFD0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ummary of key data resources and knowledge bases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F2F2597-E002-4D44-9401-75CDD40F69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0100" y="888126"/>
            <a:ext cx="3823800" cy="5133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5138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B93434-59BF-5BC3-3EEE-AB7171FA97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8765154-7827-EFF8-5BA9-1CE9F3D7BBBD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9E48498-A6E7-DD0A-D2A9-7D913572CB66}"/>
              </a:ext>
            </a:extLst>
          </p:cNvPr>
          <p:cNvSpPr txBox="1"/>
          <p:nvPr/>
        </p:nvSpPr>
        <p:spPr>
          <a:xfrm>
            <a:off x="35496" y="5661248"/>
            <a:ext cx="684076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hen et al (2026) Diabetologia DOI 10.1007/s00125-026-06731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6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E97B48-F259-359C-82F7-88252904570C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Comparison of glucose-stimulated dynamic insulin secretion from different centr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D102BBC-B92F-AC25-29BC-0F3DB8B64B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4432" y="764704"/>
            <a:ext cx="6075136" cy="5184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0703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4</cp:revision>
  <dcterms:created xsi:type="dcterms:W3CDTF">2016-06-15T12:53:43Z</dcterms:created>
  <dcterms:modified xsi:type="dcterms:W3CDTF">2026-04-10T08:04:25Z</dcterms:modified>
</cp:coreProperties>
</file>